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theme/themeOverride1.xml" ContentType="application/vnd.openxmlformats-officedocument.themeOverride+xml"/>
  <Override PartName="/ppt/charts/chart3.xml" ContentType="application/vnd.openxmlformats-officedocument.drawingml.chart+xml"/>
  <Override PartName="/ppt/theme/themeOverride2.xml" ContentType="application/vnd.openxmlformats-officedocument.themeOverride+xml"/>
  <Override PartName="/ppt/charts/chart4.xml" ContentType="application/vnd.openxmlformats-officedocument.drawingml.chart+xml"/>
  <Override PartName="/ppt/theme/themeOverride3.xml" ContentType="application/vnd.openxmlformats-officedocument.themeOverr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6"/>
  </p:notesMasterIdLst>
  <p:sldIdLst>
    <p:sldId id="295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F455457-65FF-4216-806B-84DF5C850B78}" v="151" dt="2020-04-07T11:06:47.01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63" d="100"/>
          <a:sy n="63" d="100"/>
        </p:scale>
        <p:origin x="76" y="1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akahashi Yoshito (高橋 慶人)" userId="3d5c74a6-805f-4e21-b9ae-efdbdc1a5493" providerId="ADAL" clId="{EF455457-65FF-4216-806B-84DF5C850B78}"/>
    <pc:docChg chg="undo redo custSel modSld">
      <pc:chgData name="Takahashi Yoshito (高橋 慶人)" userId="3d5c74a6-805f-4e21-b9ae-efdbdc1a5493" providerId="ADAL" clId="{EF455457-65FF-4216-806B-84DF5C850B78}" dt="2020-04-07T11:06:47.011" v="146" actId="478"/>
      <pc:docMkLst>
        <pc:docMk/>
      </pc:docMkLst>
      <pc:sldChg chg="addSp delSp modSp mod">
        <pc:chgData name="Takahashi Yoshito (高橋 慶人)" userId="3d5c74a6-805f-4e21-b9ae-efdbdc1a5493" providerId="ADAL" clId="{EF455457-65FF-4216-806B-84DF5C850B78}" dt="2020-04-07T11:06:47.011" v="146" actId="478"/>
        <pc:sldMkLst>
          <pc:docMk/>
          <pc:sldMk cId="0" sldId="295"/>
        </pc:sldMkLst>
        <pc:spChg chg="add del">
          <ac:chgData name="Takahashi Yoshito (高橋 慶人)" userId="3d5c74a6-805f-4e21-b9ae-efdbdc1a5493" providerId="ADAL" clId="{EF455457-65FF-4216-806B-84DF5C850B78}" dt="2020-04-07T11:06:47.011" v="146" actId="478"/>
          <ac:spMkLst>
            <pc:docMk/>
            <pc:sldMk cId="0" sldId="295"/>
            <ac:spMk id="4" creationId="{063089AB-F3D0-4CF5-B7EF-84CF2DE91D4E}"/>
          </ac:spMkLst>
        </pc:spChg>
        <pc:spChg chg="add del">
          <ac:chgData name="Takahashi Yoshito (高橋 慶人)" userId="3d5c74a6-805f-4e21-b9ae-efdbdc1a5493" providerId="ADAL" clId="{EF455457-65FF-4216-806B-84DF5C850B78}" dt="2020-04-07T11:06:47.011" v="146" actId="478"/>
          <ac:spMkLst>
            <pc:docMk/>
            <pc:sldMk cId="0" sldId="295"/>
            <ac:spMk id="5125" creationId="{00000000-0000-0000-0000-000000000000}"/>
          </ac:spMkLst>
        </pc:spChg>
        <pc:graphicFrameChg chg="add del mod">
          <ac:chgData name="Takahashi Yoshito (高橋 慶人)" userId="3d5c74a6-805f-4e21-b9ae-efdbdc1a5493" providerId="ADAL" clId="{EF455457-65FF-4216-806B-84DF5C850B78}" dt="2020-04-07T11:06:42.405" v="141" actId="478"/>
          <ac:graphicFrameMkLst>
            <pc:docMk/>
            <pc:sldMk cId="0" sldId="295"/>
            <ac:graphicFrameMk id="19" creationId="{00000000-0008-0000-0100-000003000000}"/>
          </ac:graphicFrameMkLst>
        </pc:graphicFrameChg>
        <pc:graphicFrameChg chg="add mod">
          <ac:chgData name="Takahashi Yoshito (高橋 慶人)" userId="3d5c74a6-805f-4e21-b9ae-efdbdc1a5493" providerId="ADAL" clId="{EF455457-65FF-4216-806B-84DF5C850B78}" dt="2020-04-07T11:06:41.443" v="140" actId="14100"/>
          <ac:graphicFrameMkLst>
            <pc:docMk/>
            <pc:sldMk cId="0" sldId="295"/>
            <ac:graphicFrameMk id="20" creationId="{00000000-0008-0000-0100-000003000000}"/>
          </ac:graphicFrameMkLst>
        </pc:graphicFrameChg>
        <pc:graphicFrameChg chg="mod">
          <ac:chgData name="Takahashi Yoshito (高橋 慶人)" userId="3d5c74a6-805f-4e21-b9ae-efdbdc1a5493" providerId="ADAL" clId="{EF455457-65FF-4216-806B-84DF5C850B78}" dt="2020-04-07T11:06:45.370" v="144" actId="1076"/>
          <ac:graphicFrameMkLst>
            <pc:docMk/>
            <pc:sldMk cId="0" sldId="295"/>
            <ac:graphicFrameMk id="69" creationId="{00000000-0000-0000-0000-000000000000}"/>
          </ac:graphicFrameMkLst>
        </pc:graphicFrame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https://kao-my.sharepoint.com/personal/336083_kao_com/Documents/&#26087;C&#65284;%20&#30333;&#26001;&#38306;&#36899;/&#21407;&#22240;&#31350;&#26126;/B&#12503;&#12525;&#12472;&#12455;&#12463;&#12488;/&#27835;&#30274;&#27861;&#38283;&#30330;/&#12475;&#12523;&#12501;&#12479;&#12531;&#12491;&#12531;&#12464;/ST&#21092;&#35542;&#25991;/200108&#25913;_190410%20ST&#21092;&#38263;&#26399;&#35430;&#39443;%20Skindex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D:\users\336083\Desktop\ST&#21092;&#35542;&#25991;\191022&#25913;_190410%20ST&#21092;&#38263;&#26399;&#35430;&#39443;%20Skindex.xlsx" TargetMode="External"/><Relationship Id="rId1" Type="http://schemas.openxmlformats.org/officeDocument/2006/relationships/themeOverride" Target="../theme/themeOverride1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D:\users\336083\Desktop\ST&#21092;&#35542;&#25991;\191022&#25913;_190410%20ST&#21092;&#38263;&#26399;&#35430;&#39443;%20Skindex.xlsx" TargetMode="External"/><Relationship Id="rId1" Type="http://schemas.openxmlformats.org/officeDocument/2006/relationships/themeOverride" Target="../theme/themeOverride2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file:///D:\users\336083\Desktop\ST&#21092;&#35542;&#25991;\191022&#25913;_190410%20ST&#21092;&#38263;&#26399;&#35430;&#39443;%20Skindex.xlsx" TargetMode="External"/><Relationship Id="rId1" Type="http://schemas.openxmlformats.org/officeDocument/2006/relationships/themeOverride" Target="../theme/themeOverrid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940507436570429"/>
          <c:y val="0.11158573928258968"/>
          <c:w val="0.70817825896762909"/>
          <c:h val="0.72078874299450002"/>
        </c:manualLayout>
      </c:layout>
      <c:lineChart>
        <c:grouping val="standard"/>
        <c:varyColors val="0"/>
        <c:ser>
          <c:idx val="8"/>
          <c:order val="0"/>
          <c:tx>
            <c:strRef>
              <c:f>Skindexグラフ!$B$10</c:f>
              <c:strCache>
                <c:ptCount val="1"/>
                <c:pt idx="0">
                  <c:v>平均</c:v>
                </c:pt>
              </c:strCache>
            </c:strRef>
          </c:tx>
          <c:spPr>
            <a:ln w="34925">
              <a:noFill/>
            </a:ln>
          </c:spPr>
          <c:marker>
            <c:symbol val="circle"/>
            <c:size val="7"/>
            <c:spPr>
              <a:solidFill>
                <a:schemeClr val="tx1"/>
              </a:solidFill>
              <a:ln w="0">
                <a:noFill/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Skindexグラフ!$C$11:$F$11</c:f>
                <c:numCache>
                  <c:formatCode>General</c:formatCode>
                  <c:ptCount val="4"/>
                  <c:pt idx="0">
                    <c:v>11.630471062809844</c:v>
                  </c:pt>
                  <c:pt idx="1">
                    <c:v>13.319561339838272</c:v>
                  </c:pt>
                  <c:pt idx="2">
                    <c:v>17.252329035317441</c:v>
                  </c:pt>
                  <c:pt idx="3">
                    <c:v>15.954735078608213</c:v>
                  </c:pt>
                </c:numCache>
              </c:numRef>
            </c:plus>
            <c:minus>
              <c:numRef>
                <c:f>Skindexグラフ!$C$11:$F$11</c:f>
                <c:numCache>
                  <c:formatCode>General</c:formatCode>
                  <c:ptCount val="4"/>
                  <c:pt idx="0">
                    <c:v>11.630471062809844</c:v>
                  </c:pt>
                  <c:pt idx="1">
                    <c:v>13.319561339838272</c:v>
                  </c:pt>
                  <c:pt idx="2">
                    <c:v>17.252329035317441</c:v>
                  </c:pt>
                  <c:pt idx="3">
                    <c:v>15.954735078608213</c:v>
                  </c:pt>
                </c:numCache>
              </c:numRef>
            </c:minus>
          </c:errBars>
          <c:cat>
            <c:strRef>
              <c:f>Skindexグラフ!$C$1:$F$1</c:f>
              <c:strCache>
                <c:ptCount val="4"/>
                <c:pt idx="0">
                  <c:v>before</c:v>
                </c:pt>
                <c:pt idx="1">
                  <c:v>1M</c:v>
                </c:pt>
                <c:pt idx="2">
                  <c:v>2M</c:v>
                </c:pt>
                <c:pt idx="3">
                  <c:v>3W after end</c:v>
                </c:pt>
              </c:strCache>
            </c:strRef>
          </c:cat>
          <c:val>
            <c:numRef>
              <c:f>Skindexグラフ!$C$10:$F$10</c:f>
              <c:numCache>
                <c:formatCode>0</c:formatCode>
                <c:ptCount val="4"/>
                <c:pt idx="0">
                  <c:v>11.875</c:v>
                </c:pt>
                <c:pt idx="1">
                  <c:v>7.375</c:v>
                </c:pt>
                <c:pt idx="2">
                  <c:v>8.25</c:v>
                </c:pt>
                <c:pt idx="3">
                  <c:v>9.37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A3BE-4F83-8BDA-6BA7F2B36BF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3059968"/>
        <c:axId val="203061504"/>
      </c:lineChart>
      <c:catAx>
        <c:axId val="20305996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03061504"/>
        <c:crosses val="autoZero"/>
        <c:auto val="1"/>
        <c:lblAlgn val="ctr"/>
        <c:lblOffset val="100"/>
        <c:noMultiLvlLbl val="0"/>
      </c:catAx>
      <c:valAx>
        <c:axId val="203061504"/>
        <c:scaling>
          <c:orientation val="minMax"/>
          <c:max val="10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Skindex-16 </a:t>
                </a:r>
                <a:r>
                  <a:rPr lang="en-US">
                    <a:solidFill>
                      <a:srgbClr val="FF0000"/>
                    </a:solidFill>
                  </a:rPr>
                  <a:t>symptoms</a:t>
                </a:r>
                <a:r>
                  <a:rPr lang="en-US"/>
                  <a:t> score</a:t>
                </a:r>
              </a:p>
            </c:rich>
          </c:tx>
          <c:overlay val="0"/>
        </c:title>
        <c:numFmt formatCode="0" sourceLinked="1"/>
        <c:majorTickMark val="out"/>
        <c:minorTickMark val="none"/>
        <c:tickLblPos val="nextTo"/>
        <c:crossAx val="203059968"/>
        <c:crosses val="autoZero"/>
        <c:crossBetween val="between"/>
        <c:majorUnit val="20"/>
      </c:valAx>
      <c:spPr>
        <a:noFill/>
      </c:spPr>
    </c:plotArea>
    <c:plotVisOnly val="1"/>
    <c:dispBlanksAs val="gap"/>
    <c:showDLblsOverMax val="0"/>
  </c:chart>
  <c:spPr>
    <a:solidFill>
      <a:schemeClr val="bg1">
        <a:alpha val="0"/>
      </a:schemeClr>
    </a:solidFill>
  </c:spPr>
  <c:txPr>
    <a:bodyPr/>
    <a:lstStyle/>
    <a:p>
      <a:pPr>
        <a:defRPr sz="1200" b="0">
          <a:latin typeface="Arial Unicode MS" panose="020B0604020202020204" pitchFamily="50" charset="-128"/>
          <a:ea typeface="Arial Unicode MS" panose="020B0604020202020204" pitchFamily="50" charset="-128"/>
          <a:cs typeface="Arial Unicode MS" panose="020B0604020202020204" pitchFamily="50" charset="-128"/>
        </a:defRPr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1940507436570429"/>
          <c:y val="0.11158573928258968"/>
          <c:w val="0.70817825896762909"/>
          <c:h val="0.70334688053319916"/>
        </c:manualLayout>
      </c:layout>
      <c:lineChart>
        <c:grouping val="standard"/>
        <c:varyColors val="0"/>
        <c:ser>
          <c:idx val="8"/>
          <c:order val="0"/>
          <c:tx>
            <c:strRef>
              <c:f>Skindexグラフ!$B$22</c:f>
              <c:strCache>
                <c:ptCount val="1"/>
                <c:pt idx="0">
                  <c:v>平均</c:v>
                </c:pt>
              </c:strCache>
            </c:strRef>
          </c:tx>
          <c:spPr>
            <a:ln w="34925">
              <a:noFill/>
            </a:ln>
          </c:spPr>
          <c:marker>
            <c:symbol val="circle"/>
            <c:size val="7"/>
            <c:spPr>
              <a:solidFill>
                <a:schemeClr val="tx1"/>
              </a:solidFill>
              <a:ln w="0">
                <a:noFill/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Skindexグラフ!$C$23:$F$23</c:f>
                <c:numCache>
                  <c:formatCode>General</c:formatCode>
                  <c:ptCount val="4"/>
                  <c:pt idx="0">
                    <c:v>24.365886574705804</c:v>
                  </c:pt>
                  <c:pt idx="1">
                    <c:v>22.765497076559896</c:v>
                  </c:pt>
                  <c:pt idx="2">
                    <c:v>22.371857321197094</c:v>
                  </c:pt>
                  <c:pt idx="3">
                    <c:v>26.384218467238782</c:v>
                  </c:pt>
                </c:numCache>
              </c:numRef>
            </c:plus>
            <c:minus>
              <c:numRef>
                <c:f>Skindexグラフ!$C$23:$F$23</c:f>
                <c:numCache>
                  <c:formatCode>General</c:formatCode>
                  <c:ptCount val="4"/>
                  <c:pt idx="0">
                    <c:v>24.365886574705804</c:v>
                  </c:pt>
                  <c:pt idx="1">
                    <c:v>22.765497076559896</c:v>
                  </c:pt>
                  <c:pt idx="2">
                    <c:v>22.371857321197094</c:v>
                  </c:pt>
                  <c:pt idx="3">
                    <c:v>26.384218467238782</c:v>
                  </c:pt>
                </c:numCache>
              </c:numRef>
            </c:minus>
          </c:errBars>
          <c:cat>
            <c:strRef>
              <c:f>Skindexグラフ!$C$13:$F$13</c:f>
              <c:strCache>
                <c:ptCount val="4"/>
                <c:pt idx="0">
                  <c:v>before</c:v>
                </c:pt>
                <c:pt idx="1">
                  <c:v>1M</c:v>
                </c:pt>
                <c:pt idx="2">
                  <c:v>2M</c:v>
                </c:pt>
                <c:pt idx="3">
                  <c:v>3W after end</c:v>
                </c:pt>
              </c:strCache>
            </c:strRef>
          </c:cat>
          <c:val>
            <c:numRef>
              <c:f>Skindexグラフ!$C$22:$F$22</c:f>
              <c:numCache>
                <c:formatCode>0</c:formatCode>
                <c:ptCount val="4"/>
                <c:pt idx="0">
                  <c:v>49.375</c:v>
                </c:pt>
                <c:pt idx="1">
                  <c:v>29.375</c:v>
                </c:pt>
                <c:pt idx="2">
                  <c:v>21.75</c:v>
                </c:pt>
                <c:pt idx="3">
                  <c:v>22.83333333333333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B0E-4FB9-B175-A239C63680E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3139328"/>
        <c:axId val="72061312"/>
      </c:lineChart>
      <c:catAx>
        <c:axId val="3313932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ja-JP"/>
          </a:p>
        </c:txPr>
        <c:crossAx val="72061312"/>
        <c:crosses val="autoZero"/>
        <c:auto val="1"/>
        <c:lblAlgn val="ctr"/>
        <c:lblOffset val="100"/>
        <c:noMultiLvlLbl val="0"/>
      </c:catAx>
      <c:valAx>
        <c:axId val="72061312"/>
        <c:scaling>
          <c:orientation val="minMax"/>
          <c:max val="10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ja-JP"/>
                </a:pPr>
                <a:r>
                  <a:rPr lang="en-US"/>
                  <a:t>Skindex-16 emotions score</a:t>
                </a:r>
              </a:p>
            </c:rich>
          </c:tx>
          <c:overlay val="0"/>
        </c:title>
        <c:numFmt formatCode="0" sourceLinked="1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ja-JP"/>
          </a:p>
        </c:txPr>
        <c:crossAx val="33139328"/>
        <c:crosses val="autoZero"/>
        <c:crossBetween val="between"/>
        <c:majorUnit val="20"/>
      </c:valAx>
      <c:spPr>
        <a:noFill/>
      </c:spPr>
    </c:plotArea>
    <c:plotVisOnly val="1"/>
    <c:dispBlanksAs val="gap"/>
    <c:showDLblsOverMax val="0"/>
  </c:chart>
  <c:spPr>
    <a:solidFill>
      <a:schemeClr val="bg1">
        <a:alpha val="0"/>
      </a:schemeClr>
    </a:solidFill>
  </c:spPr>
  <c:txPr>
    <a:bodyPr/>
    <a:lstStyle/>
    <a:p>
      <a:pPr>
        <a:defRPr sz="1200" b="0">
          <a:latin typeface="Arial Unicode MS" panose="020B0604020202020204" pitchFamily="50" charset="-128"/>
          <a:ea typeface="Arial Unicode MS" panose="020B0604020202020204" pitchFamily="50" charset="-128"/>
          <a:cs typeface="Arial Unicode MS" panose="020B0604020202020204" pitchFamily="50" charset="-128"/>
        </a:defRPr>
      </a:pPr>
      <a:endParaRPr lang="ja-JP"/>
    </a:p>
  </c:tx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1940507436570429"/>
          <c:y val="0.11158573928258968"/>
          <c:w val="0.70817825896762909"/>
          <c:h val="0.72078874299450002"/>
        </c:manualLayout>
      </c:layout>
      <c:lineChart>
        <c:grouping val="standard"/>
        <c:varyColors val="0"/>
        <c:ser>
          <c:idx val="8"/>
          <c:order val="0"/>
          <c:tx>
            <c:strRef>
              <c:f>Skindexグラフ!$B$46</c:f>
              <c:strCache>
                <c:ptCount val="1"/>
                <c:pt idx="0">
                  <c:v>平均</c:v>
                </c:pt>
              </c:strCache>
            </c:strRef>
          </c:tx>
          <c:spPr>
            <a:ln>
              <a:noFill/>
            </a:ln>
          </c:spPr>
          <c:marker>
            <c:symbol val="circle"/>
            <c:size val="7"/>
            <c:spPr>
              <a:solidFill>
                <a:schemeClr val="tx1"/>
              </a:solidFill>
              <a:ln w="0">
                <a:noFill/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Skindexグラフ!$C$47:$F$47</c:f>
                <c:numCache>
                  <c:formatCode>General</c:formatCode>
                  <c:ptCount val="4"/>
                  <c:pt idx="0">
                    <c:v>18.086597247685923</c:v>
                  </c:pt>
                  <c:pt idx="1">
                    <c:v>16.736935203316047</c:v>
                  </c:pt>
                  <c:pt idx="2">
                    <c:v>20.031671351708454</c:v>
                  </c:pt>
                  <c:pt idx="3">
                    <c:v>20.290303806779942</c:v>
                  </c:pt>
                </c:numCache>
              </c:numRef>
            </c:plus>
            <c:minus>
              <c:numRef>
                <c:f>Skindexグラフ!$C$47:$F$47</c:f>
                <c:numCache>
                  <c:formatCode>General</c:formatCode>
                  <c:ptCount val="4"/>
                  <c:pt idx="0">
                    <c:v>18.086597247685923</c:v>
                  </c:pt>
                  <c:pt idx="1">
                    <c:v>16.736935203316047</c:v>
                  </c:pt>
                  <c:pt idx="2">
                    <c:v>20.031671351708454</c:v>
                  </c:pt>
                  <c:pt idx="3">
                    <c:v>20.290303806779942</c:v>
                  </c:pt>
                </c:numCache>
              </c:numRef>
            </c:minus>
          </c:errBars>
          <c:cat>
            <c:strRef>
              <c:f>Skindexグラフ!$C$37:$F$37</c:f>
              <c:strCache>
                <c:ptCount val="4"/>
                <c:pt idx="0">
                  <c:v>before</c:v>
                </c:pt>
                <c:pt idx="1">
                  <c:v>1M</c:v>
                </c:pt>
                <c:pt idx="2">
                  <c:v>2M</c:v>
                </c:pt>
                <c:pt idx="3">
                  <c:v>3W after end</c:v>
                </c:pt>
              </c:strCache>
            </c:strRef>
          </c:cat>
          <c:val>
            <c:numRef>
              <c:f>Skindexグラフ!$C$46:$F$46</c:f>
              <c:numCache>
                <c:formatCode>0</c:formatCode>
                <c:ptCount val="4"/>
                <c:pt idx="0">
                  <c:v>31.625</c:v>
                </c:pt>
                <c:pt idx="1">
                  <c:v>17.125</c:v>
                </c:pt>
                <c:pt idx="2">
                  <c:v>16.125</c:v>
                </c:pt>
                <c:pt idx="3">
                  <c:v>15.6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99A-4C49-A401-F1885760573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2692096"/>
        <c:axId val="72693632"/>
      </c:lineChart>
      <c:catAx>
        <c:axId val="7269209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ja-JP"/>
          </a:p>
        </c:txPr>
        <c:crossAx val="72693632"/>
        <c:crosses val="autoZero"/>
        <c:auto val="1"/>
        <c:lblAlgn val="ctr"/>
        <c:lblOffset val="100"/>
        <c:tickLblSkip val="1"/>
        <c:tickMarkSkip val="4"/>
        <c:noMultiLvlLbl val="0"/>
      </c:catAx>
      <c:valAx>
        <c:axId val="72693632"/>
        <c:scaling>
          <c:orientation val="minMax"/>
          <c:max val="10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ja-JP"/>
                </a:pPr>
                <a:r>
                  <a:rPr lang="en-US"/>
                  <a:t>Skindex-16 total score</a:t>
                </a:r>
                <a:endParaRPr lang="ja-JP"/>
              </a:p>
            </c:rich>
          </c:tx>
          <c:overlay val="0"/>
        </c:title>
        <c:numFmt formatCode="0" sourceLinked="1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ja-JP"/>
          </a:p>
        </c:txPr>
        <c:crossAx val="72692096"/>
        <c:crossesAt val="0"/>
        <c:crossBetween val="between"/>
        <c:majorUnit val="20"/>
      </c:valAx>
      <c:spPr>
        <a:noFill/>
      </c:spPr>
    </c:plotArea>
    <c:plotVisOnly val="1"/>
    <c:dispBlanksAs val="gap"/>
    <c:showDLblsOverMax val="0"/>
  </c:chart>
  <c:spPr>
    <a:solidFill>
      <a:schemeClr val="bg1">
        <a:alpha val="0"/>
      </a:schemeClr>
    </a:solidFill>
  </c:spPr>
  <c:txPr>
    <a:bodyPr/>
    <a:lstStyle/>
    <a:p>
      <a:pPr>
        <a:defRPr sz="1200" b="0">
          <a:latin typeface="Arial Unicode MS" panose="020B0604020202020204" pitchFamily="50" charset="-128"/>
          <a:ea typeface="Arial Unicode MS" panose="020B0604020202020204" pitchFamily="50" charset="-128"/>
          <a:cs typeface="Arial Unicode MS" panose="020B0604020202020204" pitchFamily="50" charset="-128"/>
        </a:defRPr>
      </a:pPr>
      <a:endParaRPr lang="ja-JP"/>
    </a:p>
  </c:txPr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1940507436570429"/>
          <c:y val="0.11158573928258968"/>
          <c:w val="0.70817825896762909"/>
          <c:h val="0.72514920860982524"/>
        </c:manualLayout>
      </c:layout>
      <c:lineChart>
        <c:grouping val="standard"/>
        <c:varyColors val="0"/>
        <c:ser>
          <c:idx val="8"/>
          <c:order val="0"/>
          <c:tx>
            <c:strRef>
              <c:f>Skindexグラフ!$B$34</c:f>
              <c:strCache>
                <c:ptCount val="1"/>
                <c:pt idx="0">
                  <c:v>平均</c:v>
                </c:pt>
              </c:strCache>
            </c:strRef>
          </c:tx>
          <c:spPr>
            <a:ln w="34925">
              <a:noFill/>
            </a:ln>
          </c:spPr>
          <c:marker>
            <c:symbol val="circle"/>
            <c:size val="7"/>
            <c:spPr>
              <a:solidFill>
                <a:schemeClr val="tx1"/>
              </a:solidFill>
              <a:ln w="0">
                <a:noFill/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Skindexグラフ!$C$35:$F$35</c:f>
                <c:numCache>
                  <c:formatCode>General</c:formatCode>
                  <c:ptCount val="4"/>
                  <c:pt idx="0">
                    <c:v>29.208303613869806</c:v>
                  </c:pt>
                  <c:pt idx="1">
                    <c:v>17.618476502970235</c:v>
                  </c:pt>
                  <c:pt idx="2">
                    <c:v>26.771186536487853</c:v>
                  </c:pt>
                  <c:pt idx="3">
                    <c:v>21.390501897537874</c:v>
                  </c:pt>
                </c:numCache>
              </c:numRef>
            </c:plus>
            <c:minus>
              <c:numRef>
                <c:f>Skindexグラフ!$C$35:$F$35</c:f>
                <c:numCache>
                  <c:formatCode>General</c:formatCode>
                  <c:ptCount val="4"/>
                  <c:pt idx="0">
                    <c:v>29.208303613869806</c:v>
                  </c:pt>
                  <c:pt idx="1">
                    <c:v>17.618476502970235</c:v>
                  </c:pt>
                  <c:pt idx="2">
                    <c:v>26.771186536487853</c:v>
                  </c:pt>
                  <c:pt idx="3">
                    <c:v>21.390501897537874</c:v>
                  </c:pt>
                </c:numCache>
              </c:numRef>
            </c:minus>
          </c:errBars>
          <c:cat>
            <c:strRef>
              <c:f>Skindexグラフ!$C$25:$F$25</c:f>
              <c:strCache>
                <c:ptCount val="4"/>
                <c:pt idx="0">
                  <c:v>before</c:v>
                </c:pt>
                <c:pt idx="1">
                  <c:v>1M</c:v>
                </c:pt>
                <c:pt idx="2">
                  <c:v>2M</c:v>
                </c:pt>
                <c:pt idx="3">
                  <c:v>3W after end</c:v>
                </c:pt>
              </c:strCache>
            </c:strRef>
          </c:cat>
          <c:val>
            <c:numRef>
              <c:f>Skindexグラフ!$C$34:$F$34</c:f>
              <c:numCache>
                <c:formatCode>0</c:formatCode>
                <c:ptCount val="4"/>
                <c:pt idx="0">
                  <c:v>22.625</c:v>
                </c:pt>
                <c:pt idx="1">
                  <c:v>7.875</c:v>
                </c:pt>
                <c:pt idx="2">
                  <c:v>14.875</c:v>
                </c:pt>
                <c:pt idx="3">
                  <c:v>10.87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D7E-4B53-9AE3-306227EAD71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2144640"/>
        <c:axId val="82171008"/>
      </c:lineChart>
      <c:catAx>
        <c:axId val="8214464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ja-JP"/>
          </a:p>
        </c:txPr>
        <c:crossAx val="82171008"/>
        <c:crosses val="autoZero"/>
        <c:auto val="1"/>
        <c:lblAlgn val="ctr"/>
        <c:lblOffset val="100"/>
        <c:noMultiLvlLbl val="0"/>
      </c:catAx>
      <c:valAx>
        <c:axId val="82171008"/>
        <c:scaling>
          <c:orientation val="minMax"/>
          <c:max val="10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ja-JP"/>
                </a:pPr>
                <a:r>
                  <a:rPr lang="en-US"/>
                  <a:t>Skindex-16 fuctioning score</a:t>
                </a:r>
              </a:p>
            </c:rich>
          </c:tx>
          <c:overlay val="0"/>
        </c:title>
        <c:numFmt formatCode="0" sourceLinked="1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ja-JP"/>
          </a:p>
        </c:txPr>
        <c:crossAx val="82144640"/>
        <c:crosses val="autoZero"/>
        <c:crossBetween val="between"/>
        <c:majorUnit val="20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>
        <a:alpha val="0"/>
      </a:schemeClr>
    </a:solidFill>
  </c:spPr>
  <c:txPr>
    <a:bodyPr/>
    <a:lstStyle/>
    <a:p>
      <a:pPr>
        <a:defRPr sz="1200" b="0">
          <a:latin typeface="Arial Unicode MS" panose="020B0604020202020204" pitchFamily="50" charset="-128"/>
          <a:ea typeface="Arial Unicode MS" panose="020B0604020202020204" pitchFamily="50" charset="-128"/>
          <a:cs typeface="Arial Unicode MS" panose="020B0604020202020204" pitchFamily="50" charset="-128"/>
        </a:defRPr>
      </a:pPr>
      <a:endParaRPr lang="ja-JP"/>
    </a:p>
  </c:txPr>
  <c:externalData r:id="rId2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7FE5800-CF43-4E71-A421-FDDD75F29990}" type="datetimeFigureOut">
              <a:rPr lang="en-IN" smtClean="0"/>
              <a:t>07-04-2020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38CB5E4-AD7B-4E87-A2D3-909A9E87509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363968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>
            <a:lvl1pPr eaLnBrk="0" hangingPunct="0">
              <a:defRPr kumimoji="1" sz="2400" baseline="30000">
                <a:solidFill>
                  <a:schemeClr val="tx1"/>
                </a:solidFill>
                <a:latin typeface="Helvetica" charset="0"/>
                <a:ea typeface="Osaka" charset="-128"/>
              </a:defRPr>
            </a:lvl1pPr>
            <a:lvl2pPr marL="742950" indent="-285750" eaLnBrk="0" hangingPunct="0">
              <a:defRPr kumimoji="1" sz="2400" baseline="30000">
                <a:solidFill>
                  <a:schemeClr val="tx1"/>
                </a:solidFill>
                <a:latin typeface="Helvetica" charset="0"/>
                <a:ea typeface="Osaka" charset="-128"/>
              </a:defRPr>
            </a:lvl2pPr>
            <a:lvl3pPr marL="1143000" indent="-228600" eaLnBrk="0" hangingPunct="0">
              <a:defRPr kumimoji="1" sz="2400" baseline="30000">
                <a:solidFill>
                  <a:schemeClr val="tx1"/>
                </a:solidFill>
                <a:latin typeface="Helvetica" charset="0"/>
                <a:ea typeface="Osaka" charset="-128"/>
              </a:defRPr>
            </a:lvl3pPr>
            <a:lvl4pPr marL="1600200" indent="-228600" eaLnBrk="0" hangingPunct="0">
              <a:defRPr kumimoji="1" sz="2400" baseline="30000">
                <a:solidFill>
                  <a:schemeClr val="tx1"/>
                </a:solidFill>
                <a:latin typeface="Helvetica" charset="0"/>
                <a:ea typeface="Osaka" charset="-128"/>
              </a:defRPr>
            </a:lvl4pPr>
            <a:lvl5pPr marL="2057400" indent="-228600" eaLnBrk="0" hangingPunct="0">
              <a:defRPr kumimoji="1" sz="2400" baseline="30000">
                <a:solidFill>
                  <a:schemeClr val="tx1"/>
                </a:solidFill>
                <a:latin typeface="Helvetica" charset="0"/>
                <a:ea typeface="Osaka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 baseline="30000">
                <a:solidFill>
                  <a:schemeClr val="tx1"/>
                </a:solidFill>
                <a:latin typeface="Helvetica" charset="0"/>
                <a:ea typeface="Osaka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 baseline="30000">
                <a:solidFill>
                  <a:schemeClr val="tx1"/>
                </a:solidFill>
                <a:latin typeface="Helvetica" charset="0"/>
                <a:ea typeface="Osaka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 baseline="30000">
                <a:solidFill>
                  <a:schemeClr val="tx1"/>
                </a:solidFill>
                <a:latin typeface="Helvetica" charset="0"/>
                <a:ea typeface="Osaka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 baseline="30000">
                <a:solidFill>
                  <a:schemeClr val="tx1"/>
                </a:solidFill>
                <a:latin typeface="Helvetica" charset="0"/>
                <a:ea typeface="Osaka" charset="-128"/>
              </a:defRPr>
            </a:lvl9pPr>
          </a:lstStyle>
          <a:p>
            <a:pPr eaLnBrk="1" hangingPunct="1"/>
            <a:fld id="{5E79BB76-7753-49C0-AADB-93440A76BAE3}" type="slidenum">
              <a:rPr lang="en-US" altLang="ja-JP" sz="1200" baseline="0">
                <a:latin typeface="Times" charset="0"/>
              </a:rPr>
              <a:pPr eaLnBrk="1" hangingPunct="1"/>
              <a:t>1</a:t>
            </a:fld>
            <a:endParaRPr lang="en-US" altLang="ja-JP" sz="1200" baseline="0">
              <a:latin typeface="Times" charset="0"/>
            </a:endParaRPr>
          </a:p>
        </p:txBody>
      </p:sp>
      <p:sp>
        <p:nvSpPr>
          <p:cNvPr id="10243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0244" name="Rectangle 3"/>
          <p:cNvSpPr>
            <a:spLocks noGrp="1" noChangeArrowheads="1"/>
          </p:cNvSpPr>
          <p:nvPr>
            <p:ph type="body" idx="1"/>
          </p:nvPr>
        </p:nvSpPr>
        <p:spPr>
          <a:noFill/>
        </p:spPr>
        <p:txBody>
          <a:bodyPr/>
          <a:lstStyle/>
          <a:p>
            <a:pPr eaLnBrk="1" hangingPunct="1"/>
            <a:endParaRPr lang="ja-JP" altLang="ja-JP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2DFD45-D6BE-4758-8821-AE4E2560364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98BABC9-65A9-4B36-A8E8-E2727A65830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5BD017-6061-482E-9949-0351954ACB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4B84E-6DF9-4DDB-8B2B-291E65AD4FE9}" type="datetimeFigureOut">
              <a:rPr lang="en-IN" smtClean="0"/>
              <a:t>07-04-2020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C45C51-18F0-430A-B17A-0832689BEB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5B54FA-DD13-4E4A-A7D2-8EA74D6A86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6FBBD5-9194-4DE0-A195-1BC88357FFC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134129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F22813-C832-4C8C-8FBD-7D499197B3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5AC2111-534C-4B34-A10B-29FB9ED7FE5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C34BDD-38B8-4CEC-9F9D-5102F97AA3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4B84E-6DF9-4DDB-8B2B-291E65AD4FE9}" type="datetimeFigureOut">
              <a:rPr lang="en-IN" smtClean="0"/>
              <a:t>07-04-2020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619F74-686A-4AB8-806E-32FAD14D05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A1F0B2-DFDC-4292-AFB9-BA71744AB7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6FBBD5-9194-4DE0-A195-1BC88357FFC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911142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02CA951-7150-413B-83E1-EE284A1BD43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8FBA485-C357-4318-9484-BABC1168B4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D6EB78D-9688-4FE2-92F8-D42CE45893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4B84E-6DF9-4DDB-8B2B-291E65AD4FE9}" type="datetimeFigureOut">
              <a:rPr lang="en-IN" smtClean="0"/>
              <a:t>07-04-2020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B6314CA-5794-43EC-886A-2101185202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533290-62EE-49A1-9F32-CA14F4F221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6FBBD5-9194-4DE0-A195-1BC88357FFC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898398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6658F5-6D3B-4603-9047-7D84D5BFAA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D943744-C339-4DE5-ACF4-7991BBE2F59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0E126C-ADD0-40A8-8282-3016E2F3AA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4B84E-6DF9-4DDB-8B2B-291E65AD4FE9}" type="datetimeFigureOut">
              <a:rPr lang="en-IN" smtClean="0"/>
              <a:t>07-04-2020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F72DC3-FE08-41CF-B4CB-EBAD855FB0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1A9471-0F38-4338-8F58-CC16D347F5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6FBBD5-9194-4DE0-A195-1BC88357FFC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892242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331E28-6BEE-4553-A1FE-6B8D79937C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5155683-6CCB-4261-92EF-FBA78DA355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E6A220-FB34-479C-A08A-238D4EBB74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4B84E-6DF9-4DDB-8B2B-291E65AD4FE9}" type="datetimeFigureOut">
              <a:rPr lang="en-IN" smtClean="0"/>
              <a:t>07-04-2020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FDE447-F5F1-4D3F-894B-F5C2A9705F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BAD64C-9BAE-46BA-BB53-DC62515A70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6FBBD5-9194-4DE0-A195-1BC88357FFC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652540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397398-C149-4BA9-98D5-E4159636C8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3B867C4-2854-4F9B-A956-DFF8A3B980F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B62921E-1A55-41EF-8C82-7474A7F8F7C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3C2A17A-770E-4652-A0E3-982117F930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4B84E-6DF9-4DDB-8B2B-291E65AD4FE9}" type="datetimeFigureOut">
              <a:rPr lang="en-IN" smtClean="0"/>
              <a:t>07-04-2020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0BC2B97-09E5-4D54-889B-87EA9BB9CB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4F25FF7-AA46-4B14-B42A-DEDC827E68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6FBBD5-9194-4DE0-A195-1BC88357FFC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692309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BA5D11-6BB2-45FA-A2E6-EF61CDF29E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4C74E8D-6BA7-4D7F-8A1F-D7611BF8C0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25A838C-67DE-4581-87FE-662F02263C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A09B646-047B-4EA1-B0EE-87913ED6C64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A3E5FAF-E7F2-4F1E-8DD0-5EB2402E892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C4592E9-2B11-4A5E-BD77-60E823B3FB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4B84E-6DF9-4DDB-8B2B-291E65AD4FE9}" type="datetimeFigureOut">
              <a:rPr lang="en-IN" smtClean="0"/>
              <a:t>07-04-2020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BCB9E6E-AF7A-4C71-BABC-AC46BA55EB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574760F-8307-426D-BCD5-C795202AEA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6FBBD5-9194-4DE0-A195-1BC88357FFC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93411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E21F82-62F9-4648-B79D-6B71BD3099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3597107-89F4-4984-8F9D-FD6DD722DD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4B84E-6DF9-4DDB-8B2B-291E65AD4FE9}" type="datetimeFigureOut">
              <a:rPr lang="en-IN" smtClean="0"/>
              <a:t>07-04-2020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FC9D1CD-945D-427B-A8CA-5BB81398CE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91FCE1A-A1D0-4F84-82BD-DBBF8CD96B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6FBBD5-9194-4DE0-A195-1BC88357FFC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106326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EAAFF48-6332-421D-B360-9A6C548B2A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4B84E-6DF9-4DDB-8B2B-291E65AD4FE9}" type="datetimeFigureOut">
              <a:rPr lang="en-IN" smtClean="0"/>
              <a:t>07-04-2020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5176DA9-59A2-4507-BE3F-B01A02B827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FEA0581-0342-4E46-974E-9259F881AE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6FBBD5-9194-4DE0-A195-1BC88357FFC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551648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0E456A-93D7-4E17-A834-6B0A39E840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E21A760-AF61-4C24-8187-D31182BBE9A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C5519B9-A81C-451E-9401-5B668A189B9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A21C09C-3C98-4D19-A74E-AB160D19B1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4B84E-6DF9-4DDB-8B2B-291E65AD4FE9}" type="datetimeFigureOut">
              <a:rPr lang="en-IN" smtClean="0"/>
              <a:t>07-04-2020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243A0F5-C25F-4E47-9AF4-AFC95270D1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2E435F3-7286-493A-A023-C237A23341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6FBBD5-9194-4DE0-A195-1BC88357FFC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947726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9CF089-D4FA-450C-99A9-9B3130058E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9675620-740A-4F32-BBBD-77886E6B82E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F2E4B19-FB5E-49D1-8366-05BB0A521D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41AD5C1-524C-48BB-AEFA-673C020767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4B84E-6DF9-4DDB-8B2B-291E65AD4FE9}" type="datetimeFigureOut">
              <a:rPr lang="en-IN" smtClean="0"/>
              <a:t>07-04-2020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966C91A-B1EC-4507-A624-BC9231F99C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606B1D5-0DA1-4BA1-A742-87B4F13A13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6FBBD5-9194-4DE0-A195-1BC88357FFC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332492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1E88C00-0FAF-452F-98CD-7BE32E1A63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930A6ED-9734-45BC-83C4-290B5A5D4D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3A1218-A458-4664-8FB6-473308314F9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A4B84E-6DF9-4DDB-8B2B-291E65AD4FE9}" type="datetimeFigureOut">
              <a:rPr lang="en-IN" smtClean="0"/>
              <a:t>07-04-2020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35325A-83B6-4452-9EA7-EBD6E31F81A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A70B79-6425-4D1A-886D-138C7F79293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6FBBD5-9194-4DE0-A195-1BC88357FFC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65706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0" name="グラフ 19">
            <a:extLst>
              <a:ext uri="{FF2B5EF4-FFF2-40B4-BE49-F238E27FC236}">
                <a16:creationId xmlns:a16="http://schemas.microsoft.com/office/drawing/2014/main" id="{00000000-0008-0000-01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97343183"/>
              </p:ext>
            </p:extLst>
          </p:nvPr>
        </p:nvGraphicFramePr>
        <p:xfrm>
          <a:off x="6180076" y="3706542"/>
          <a:ext cx="5097989" cy="29478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8" name="グラフ 67"/>
          <p:cNvGraphicFramePr>
            <a:graphicFrameLocks/>
          </p:cNvGraphicFramePr>
          <p:nvPr/>
        </p:nvGraphicFramePr>
        <p:xfrm>
          <a:off x="6168009" y="451214"/>
          <a:ext cx="5120217" cy="29019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0" name="グラフ 69"/>
          <p:cNvGraphicFramePr>
            <a:graphicFrameLocks/>
          </p:cNvGraphicFramePr>
          <p:nvPr/>
        </p:nvGraphicFramePr>
        <p:xfrm>
          <a:off x="1385619" y="409683"/>
          <a:ext cx="5120217" cy="29125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5124" name="Text Box 27"/>
          <p:cNvSpPr txBox="1">
            <a:spLocks noChangeAspect="1" noChangeArrowheads="1"/>
          </p:cNvSpPr>
          <p:nvPr/>
        </p:nvSpPr>
        <p:spPr bwMode="auto">
          <a:xfrm>
            <a:off x="9715501" y="25401"/>
            <a:ext cx="1361982" cy="4044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lIns="95761" tIns="47880" rIns="95761" bIns="47880">
            <a:spAutoFit/>
          </a:bodyPr>
          <a:lstStyle>
            <a:lvl1pPr defTabSz="958850" eaLnBrk="0" hangingPunct="0">
              <a:spcBef>
                <a:spcPct val="20000"/>
              </a:spcBef>
              <a:buChar char="•"/>
              <a:defRPr kumimoji="1" sz="3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477838" indent="-300038" defTabSz="958850" eaLnBrk="0" hangingPunct="0">
              <a:spcBef>
                <a:spcPct val="20000"/>
              </a:spcBef>
              <a:buChar char="–"/>
              <a:defRPr kumimoji="1" sz="29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958850" indent="-238125" defTabSz="958850" eaLnBrk="0" hangingPunct="0">
              <a:spcBef>
                <a:spcPct val="20000"/>
              </a:spcBef>
              <a:buChar char="•"/>
              <a:defRPr kumimoji="1" sz="25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436688" indent="-239713" defTabSz="958850" eaLnBrk="0" hangingPunct="0">
              <a:spcBef>
                <a:spcPct val="20000"/>
              </a:spcBef>
              <a:buChar char="–"/>
              <a:defRPr kumimoji="1" sz="21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1916113" indent="-239713" defTabSz="958850" eaLnBrk="0" hangingPunct="0">
              <a:spcBef>
                <a:spcPct val="20000"/>
              </a:spcBef>
              <a:buChar char="»"/>
              <a:defRPr kumimoji="1" sz="21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373313" indent="-239713" defTabSz="95885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1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830513" indent="-239713" defTabSz="95885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1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287713" indent="-239713" defTabSz="95885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1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744913" indent="-239713" defTabSz="95885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1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2000" b="1" dirty="0">
                <a:latin typeface="Helvetica" charset="0"/>
              </a:rPr>
              <a:t>Figure S1</a:t>
            </a:r>
          </a:p>
        </p:txBody>
      </p:sp>
      <p:sp>
        <p:nvSpPr>
          <p:cNvPr id="5126" name="Text Box 136"/>
          <p:cNvSpPr txBox="1">
            <a:spLocks noChangeArrowheads="1"/>
          </p:cNvSpPr>
          <p:nvPr/>
        </p:nvSpPr>
        <p:spPr bwMode="auto">
          <a:xfrm>
            <a:off x="1416050" y="3500438"/>
            <a:ext cx="336060" cy="4044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lIns="95761" tIns="47880" rIns="95761" bIns="47880">
            <a:spAutoFit/>
          </a:bodyPr>
          <a:lstStyle>
            <a:lvl1pPr defTabSz="958850" eaLnBrk="0" hangingPunct="0">
              <a:spcBef>
                <a:spcPct val="20000"/>
              </a:spcBef>
              <a:buChar char="•"/>
              <a:defRPr kumimoji="1" sz="3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477838" indent="-300038" defTabSz="958850" eaLnBrk="0" hangingPunct="0">
              <a:spcBef>
                <a:spcPct val="20000"/>
              </a:spcBef>
              <a:buChar char="–"/>
              <a:defRPr kumimoji="1" sz="29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958850" indent="-238125" defTabSz="958850" eaLnBrk="0" hangingPunct="0">
              <a:spcBef>
                <a:spcPct val="20000"/>
              </a:spcBef>
              <a:buChar char="•"/>
              <a:defRPr kumimoji="1" sz="25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436688" indent="-239713" defTabSz="958850" eaLnBrk="0" hangingPunct="0">
              <a:spcBef>
                <a:spcPct val="20000"/>
              </a:spcBef>
              <a:buChar char="–"/>
              <a:defRPr kumimoji="1" sz="21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1916113" indent="-239713" defTabSz="958850" eaLnBrk="0" hangingPunct="0">
              <a:spcBef>
                <a:spcPct val="20000"/>
              </a:spcBef>
              <a:buChar char="»"/>
              <a:defRPr kumimoji="1" sz="21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373313" indent="-239713" defTabSz="95885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1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830513" indent="-239713" defTabSz="95885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1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287713" indent="-239713" defTabSz="95885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1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744913" indent="-239713" defTabSz="95885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1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2000" b="1">
                <a:latin typeface="Helvetica" charset="0"/>
              </a:rPr>
              <a:t>c</a:t>
            </a:r>
          </a:p>
        </p:txBody>
      </p:sp>
      <p:sp>
        <p:nvSpPr>
          <p:cNvPr id="5127" name="Text Box 42"/>
          <p:cNvSpPr txBox="1">
            <a:spLocks noChangeAspect="1" noChangeArrowheads="1"/>
          </p:cNvSpPr>
          <p:nvPr/>
        </p:nvSpPr>
        <p:spPr bwMode="auto">
          <a:xfrm>
            <a:off x="1416050" y="260350"/>
            <a:ext cx="336060" cy="4044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lIns="95761" tIns="47880" rIns="95761" bIns="47880">
            <a:spAutoFit/>
          </a:bodyPr>
          <a:lstStyle>
            <a:lvl1pPr defTabSz="958850" eaLnBrk="0" hangingPunct="0">
              <a:spcBef>
                <a:spcPct val="20000"/>
              </a:spcBef>
              <a:buChar char="•"/>
              <a:defRPr kumimoji="1" sz="3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477838" indent="-300038" defTabSz="958850" eaLnBrk="0" hangingPunct="0">
              <a:spcBef>
                <a:spcPct val="20000"/>
              </a:spcBef>
              <a:buChar char="–"/>
              <a:defRPr kumimoji="1" sz="29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958850" indent="-238125" defTabSz="958850" eaLnBrk="0" hangingPunct="0">
              <a:spcBef>
                <a:spcPct val="20000"/>
              </a:spcBef>
              <a:buChar char="•"/>
              <a:defRPr kumimoji="1" sz="25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436688" indent="-239713" defTabSz="958850" eaLnBrk="0" hangingPunct="0">
              <a:spcBef>
                <a:spcPct val="20000"/>
              </a:spcBef>
              <a:buChar char="–"/>
              <a:defRPr kumimoji="1" sz="21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1916113" indent="-239713" defTabSz="958850" eaLnBrk="0" hangingPunct="0">
              <a:spcBef>
                <a:spcPct val="20000"/>
              </a:spcBef>
              <a:buChar char="»"/>
              <a:defRPr kumimoji="1" sz="21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373313" indent="-239713" defTabSz="95885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1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830513" indent="-239713" defTabSz="95885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1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287713" indent="-239713" defTabSz="95885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1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744913" indent="-239713" defTabSz="95885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1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2000" b="1">
                <a:latin typeface="Helvetica" charset="0"/>
              </a:rPr>
              <a:t>a</a:t>
            </a:r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3414713" y="2349500"/>
            <a:ext cx="364202" cy="36933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none">
            <a:spAutoFit/>
          </a:bodyPr>
          <a:lstStyle/>
          <a:p>
            <a:pPr>
              <a:defRPr/>
            </a:pPr>
            <a:r>
              <a:rPr lang="ja-JP" altLang="en-US" b="1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**</a:t>
            </a:r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4324350" y="2349500"/>
            <a:ext cx="364202" cy="36933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none">
            <a:spAutoFit/>
          </a:bodyPr>
          <a:lstStyle/>
          <a:p>
            <a:pPr>
              <a:defRPr/>
            </a:pPr>
            <a:r>
              <a:rPr lang="ja-JP" altLang="en-US" b="1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**</a:t>
            </a:r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5232400" y="2349500"/>
            <a:ext cx="364202" cy="36933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none">
            <a:spAutoFit/>
          </a:bodyPr>
          <a:lstStyle/>
          <a:p>
            <a:pPr>
              <a:defRPr/>
            </a:pPr>
            <a:r>
              <a:rPr lang="ja-JP" altLang="en-US" b="1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**</a:t>
            </a:r>
          </a:p>
        </p:txBody>
      </p:sp>
      <p:sp>
        <p:nvSpPr>
          <p:cNvPr id="5131" name="Text Box 22"/>
          <p:cNvSpPr txBox="1">
            <a:spLocks noChangeArrowheads="1"/>
          </p:cNvSpPr>
          <p:nvPr/>
        </p:nvSpPr>
        <p:spPr bwMode="auto">
          <a:xfrm>
            <a:off x="6167439" y="260350"/>
            <a:ext cx="350487" cy="4044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lIns="95761" tIns="47880" rIns="95761" bIns="47880">
            <a:spAutoFit/>
          </a:bodyPr>
          <a:lstStyle>
            <a:lvl1pPr defTabSz="958850" eaLnBrk="0" hangingPunct="0">
              <a:spcBef>
                <a:spcPct val="20000"/>
              </a:spcBef>
              <a:buChar char="•"/>
              <a:defRPr kumimoji="1" sz="3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477838" indent="-300038" defTabSz="958850" eaLnBrk="0" hangingPunct="0">
              <a:spcBef>
                <a:spcPct val="20000"/>
              </a:spcBef>
              <a:buChar char="–"/>
              <a:defRPr kumimoji="1" sz="29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958850" indent="-238125" defTabSz="958850" eaLnBrk="0" hangingPunct="0">
              <a:spcBef>
                <a:spcPct val="20000"/>
              </a:spcBef>
              <a:buChar char="•"/>
              <a:defRPr kumimoji="1" sz="25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436688" indent="-239713" defTabSz="958850" eaLnBrk="0" hangingPunct="0">
              <a:spcBef>
                <a:spcPct val="20000"/>
              </a:spcBef>
              <a:buChar char="–"/>
              <a:defRPr kumimoji="1" sz="21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1916113" indent="-239713" defTabSz="958850" eaLnBrk="0" hangingPunct="0">
              <a:spcBef>
                <a:spcPct val="20000"/>
              </a:spcBef>
              <a:buChar char="»"/>
              <a:defRPr kumimoji="1" sz="21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373313" indent="-239713" defTabSz="95885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1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830513" indent="-239713" defTabSz="95885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1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287713" indent="-239713" defTabSz="95885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1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744913" indent="-239713" defTabSz="95885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1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2000" b="1">
                <a:latin typeface="Helvetica" charset="0"/>
              </a:rPr>
              <a:t>b</a:t>
            </a:r>
          </a:p>
        </p:txBody>
      </p:sp>
      <p:sp>
        <p:nvSpPr>
          <p:cNvPr id="60" name="テキスト ボックス 59"/>
          <p:cNvSpPr txBox="1"/>
          <p:nvPr/>
        </p:nvSpPr>
        <p:spPr>
          <a:xfrm>
            <a:off x="8207375" y="2112963"/>
            <a:ext cx="364202" cy="36933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none">
            <a:spAutoFit/>
          </a:bodyPr>
          <a:lstStyle/>
          <a:p>
            <a:pPr>
              <a:defRPr/>
            </a:pPr>
            <a:r>
              <a:rPr lang="ja-JP" altLang="en-US" b="1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**</a:t>
            </a:r>
          </a:p>
        </p:txBody>
      </p:sp>
      <p:sp>
        <p:nvSpPr>
          <p:cNvPr id="61" name="テキスト ボックス 60"/>
          <p:cNvSpPr txBox="1"/>
          <p:nvPr/>
        </p:nvSpPr>
        <p:spPr>
          <a:xfrm>
            <a:off x="9048750" y="2225675"/>
            <a:ext cx="364202" cy="36933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none">
            <a:spAutoFit/>
          </a:bodyPr>
          <a:lstStyle/>
          <a:p>
            <a:pPr>
              <a:defRPr/>
            </a:pPr>
            <a:r>
              <a:rPr lang="ja-JP" altLang="en-US" b="1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**</a:t>
            </a:r>
          </a:p>
        </p:txBody>
      </p:sp>
      <p:sp>
        <p:nvSpPr>
          <p:cNvPr id="62" name="テキスト ボックス 61"/>
          <p:cNvSpPr txBox="1"/>
          <p:nvPr/>
        </p:nvSpPr>
        <p:spPr>
          <a:xfrm>
            <a:off x="9983788" y="2205038"/>
            <a:ext cx="364202" cy="36933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none">
            <a:spAutoFit/>
          </a:bodyPr>
          <a:lstStyle/>
          <a:p>
            <a:pPr>
              <a:defRPr/>
            </a:pPr>
            <a:r>
              <a:rPr lang="ja-JP" altLang="en-US" b="1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**</a:t>
            </a:r>
          </a:p>
        </p:txBody>
      </p:sp>
      <p:graphicFrame>
        <p:nvGraphicFramePr>
          <p:cNvPr id="69" name="グラフ 68"/>
          <p:cNvGraphicFramePr>
            <a:graphicFrameLocks/>
          </p:cNvGraphicFramePr>
          <p:nvPr/>
        </p:nvGraphicFramePr>
        <p:xfrm>
          <a:off x="1385619" y="3696087"/>
          <a:ext cx="5198533" cy="29125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71" name="テキスト ボックス 70"/>
          <p:cNvSpPr txBox="1"/>
          <p:nvPr/>
        </p:nvSpPr>
        <p:spPr>
          <a:xfrm>
            <a:off x="3414713" y="5813425"/>
            <a:ext cx="274434" cy="36933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none">
            <a:spAutoFit/>
          </a:bodyPr>
          <a:lstStyle/>
          <a:p>
            <a:pPr>
              <a:defRPr/>
            </a:pPr>
            <a:r>
              <a:rPr lang="ja-JP" altLang="en-US" b="1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*</a:t>
            </a:r>
          </a:p>
        </p:txBody>
      </p:sp>
      <p:sp>
        <p:nvSpPr>
          <p:cNvPr id="73" name="テキスト ボックス 72"/>
          <p:cNvSpPr txBox="1"/>
          <p:nvPr/>
        </p:nvSpPr>
        <p:spPr>
          <a:xfrm>
            <a:off x="5259388" y="5773738"/>
            <a:ext cx="274434" cy="36933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none">
            <a:spAutoFit/>
          </a:bodyPr>
          <a:lstStyle/>
          <a:p>
            <a:pPr>
              <a:defRPr/>
            </a:pPr>
            <a:r>
              <a:rPr lang="ja-JP" altLang="en-US" b="1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*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新しいプレゼンテーション 1">
    <a:dk1>
      <a:srgbClr val="000000"/>
    </a:dk1>
    <a:lt1>
      <a:srgbClr val="FFFFFF"/>
    </a:lt1>
    <a:dk2>
      <a:srgbClr val="000000"/>
    </a:dk2>
    <a:lt2>
      <a:srgbClr val="808080"/>
    </a:lt2>
    <a:accent1>
      <a:srgbClr val="BBE0E3"/>
    </a:accent1>
    <a:accent2>
      <a:srgbClr val="333399"/>
    </a:accent2>
    <a:accent3>
      <a:srgbClr val="FFFFFF"/>
    </a:accent3>
    <a:accent4>
      <a:srgbClr val="000000"/>
    </a:accent4>
    <a:accent5>
      <a:srgbClr val="DAEDEF"/>
    </a:accent5>
    <a:accent6>
      <a:srgbClr val="2D2D8A"/>
    </a:accent6>
    <a:hlink>
      <a:srgbClr val="009999"/>
    </a:hlink>
    <a:folHlink>
      <a:srgbClr val="99CC00"/>
    </a:folHlink>
  </a:clrScheme>
  <a:fontScheme name="新しいプレゼンテーション">
    <a:majorFont>
      <a:latin typeface="Times"/>
      <a:ea typeface="Osaka"/>
      <a:cs typeface=""/>
    </a:majorFont>
    <a:minorFont>
      <a:latin typeface="Times"/>
      <a:ea typeface="Osaka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新しいプレゼンテーション 1">
    <a:dk1>
      <a:srgbClr val="000000"/>
    </a:dk1>
    <a:lt1>
      <a:srgbClr val="FFFFFF"/>
    </a:lt1>
    <a:dk2>
      <a:srgbClr val="000000"/>
    </a:dk2>
    <a:lt2>
      <a:srgbClr val="808080"/>
    </a:lt2>
    <a:accent1>
      <a:srgbClr val="BBE0E3"/>
    </a:accent1>
    <a:accent2>
      <a:srgbClr val="333399"/>
    </a:accent2>
    <a:accent3>
      <a:srgbClr val="FFFFFF"/>
    </a:accent3>
    <a:accent4>
      <a:srgbClr val="000000"/>
    </a:accent4>
    <a:accent5>
      <a:srgbClr val="DAEDEF"/>
    </a:accent5>
    <a:accent6>
      <a:srgbClr val="2D2D8A"/>
    </a:accent6>
    <a:hlink>
      <a:srgbClr val="009999"/>
    </a:hlink>
    <a:folHlink>
      <a:srgbClr val="99CC00"/>
    </a:folHlink>
  </a:clrScheme>
  <a:fontScheme name="新しいプレゼンテーション">
    <a:majorFont>
      <a:latin typeface="Times"/>
      <a:ea typeface="Osaka"/>
      <a:cs typeface=""/>
    </a:majorFont>
    <a:minorFont>
      <a:latin typeface="Times"/>
      <a:ea typeface="Osaka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新しいプレゼンテーション 1">
    <a:dk1>
      <a:srgbClr val="000000"/>
    </a:dk1>
    <a:lt1>
      <a:srgbClr val="FFFFFF"/>
    </a:lt1>
    <a:dk2>
      <a:srgbClr val="000000"/>
    </a:dk2>
    <a:lt2>
      <a:srgbClr val="808080"/>
    </a:lt2>
    <a:accent1>
      <a:srgbClr val="BBE0E3"/>
    </a:accent1>
    <a:accent2>
      <a:srgbClr val="333399"/>
    </a:accent2>
    <a:accent3>
      <a:srgbClr val="FFFFFF"/>
    </a:accent3>
    <a:accent4>
      <a:srgbClr val="000000"/>
    </a:accent4>
    <a:accent5>
      <a:srgbClr val="DAEDEF"/>
    </a:accent5>
    <a:accent6>
      <a:srgbClr val="2D2D8A"/>
    </a:accent6>
    <a:hlink>
      <a:srgbClr val="009999"/>
    </a:hlink>
    <a:folHlink>
      <a:srgbClr val="99CC00"/>
    </a:folHlink>
  </a:clrScheme>
  <a:fontScheme name="新しいプレゼンテーション">
    <a:majorFont>
      <a:latin typeface="Times"/>
      <a:ea typeface="Osaka"/>
      <a:cs typeface=""/>
    </a:majorFont>
    <a:minorFont>
      <a:latin typeface="Times"/>
      <a:ea typeface="Osaka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D4B9EBA92216F3458B5C84281E4EE42F" ma:contentTypeVersion="13" ma:contentTypeDescription="新しいドキュメントを作成します。" ma:contentTypeScope="" ma:versionID="a7f8ceb76a5029ef598233489bac6ba5">
  <xsd:schema xmlns:xsd="http://www.w3.org/2001/XMLSchema" xmlns:xs="http://www.w3.org/2001/XMLSchema" xmlns:p="http://schemas.microsoft.com/office/2006/metadata/properties" xmlns:ns3="322596d5-e965-453b-a2f0-e4f7fe72565a" xmlns:ns4="a730ae63-93a0-4ae2-9e86-392e8a01305f" targetNamespace="http://schemas.microsoft.com/office/2006/metadata/properties" ma:root="true" ma:fieldsID="2cb02059cca2e62e92c53e6045c9882b" ns3:_="" ns4:_="">
    <xsd:import namespace="322596d5-e965-453b-a2f0-e4f7fe72565a"/>
    <xsd:import namespace="a730ae63-93a0-4ae2-9e86-392e8a01305f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DateTaken" minOccurs="0"/>
                <xsd:element ref="ns3:MediaServiceLocation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22596d5-e965-453b-a2f0-e4f7fe72565a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4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5" nillable="true" ma:displayName="Location" ma:internalName="MediaServiceLocation" ma:readOnly="true">
      <xsd:simpleType>
        <xsd:restriction base="dms:Text"/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730ae63-93a0-4ae2-9e86-392e8a01305f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共有相手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共有相手の詳細情報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0" nillable="true" ma:displayName="共有のヒントのハッシュ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E9C38EDA-552D-46FD-859A-BD10BE8D2868}">
  <ds:schemaRefs>
    <ds:schemaRef ds:uri="http://schemas.microsoft.com/office/2006/metadata/properties"/>
    <ds:schemaRef ds:uri="http://schemas.openxmlformats.org/package/2006/metadata/core-properties"/>
    <ds:schemaRef ds:uri="http://purl.org/dc/terms/"/>
    <ds:schemaRef ds:uri="a730ae63-93a0-4ae2-9e86-392e8a01305f"/>
    <ds:schemaRef ds:uri="http://purl.org/dc/elements/1.1/"/>
    <ds:schemaRef ds:uri="http://schemas.microsoft.com/office/infopath/2007/PartnerControls"/>
    <ds:schemaRef ds:uri="http://schemas.microsoft.com/office/2006/documentManagement/types"/>
    <ds:schemaRef ds:uri="http://www.w3.org/XML/1998/namespace"/>
    <ds:schemaRef ds:uri="322596d5-e965-453b-a2f0-e4f7fe72565a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EEC9AECB-0E5A-48C7-8D2F-AA7E587425F1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E7DA678D-0687-4542-A2A1-864C46164E77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322596d5-e965-453b-a2f0-e4f7fe72565a"/>
    <ds:schemaRef ds:uri="a730ae63-93a0-4ae2-9e86-392e8a01305f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32</Words>
  <Application>Microsoft Office PowerPoint</Application>
  <PresentationFormat>ワイド画面</PresentationFormat>
  <Paragraphs>17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10" baseType="lpstr">
      <vt:lpstr>Arial Unicode MS</vt:lpstr>
      <vt:lpstr>Osaka</vt:lpstr>
      <vt:lpstr>游ゴシック</vt:lpstr>
      <vt:lpstr>Arial</vt:lpstr>
      <vt:lpstr>Calibri</vt:lpstr>
      <vt:lpstr>Calibri Light</vt:lpstr>
      <vt:lpstr>Helvetica</vt:lpstr>
      <vt:lpstr>Times</vt:lpstr>
      <vt:lpstr>Office Theme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uthor</dc:creator>
  <cp:lastModifiedBy>Takahashi Yoshito (高橋 慶人)</cp:lastModifiedBy>
  <cp:revision>2</cp:revision>
  <dcterms:created xsi:type="dcterms:W3CDTF">2019-12-19T16:48:13Z</dcterms:created>
  <dcterms:modified xsi:type="dcterms:W3CDTF">2020-04-07T11:06:5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4B9EBA92216F3458B5C84281E4EE42F</vt:lpwstr>
  </property>
</Properties>
</file>